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2" r:id="rId2"/>
  </p:sldIdLst>
  <p:sldSz cx="16200438" cy="12192000"/>
  <p:notesSz cx="9928225" cy="6797675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510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mia Boukhibar" initials="LB" lastIdx="1" clrIdx="0">
    <p:extLst/>
  </p:cmAuthor>
  <p:cmAuthor id="2" name="Microsoft Office User" initials="Office" lastIdx="1" clrIdx="1">
    <p:extLst/>
  </p:cmAuthor>
  <p:cmAuthor id="3" name="Microsoft Office User" initials="Office [2]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B3B3"/>
    <a:srgbClr val="616161"/>
    <a:srgbClr val="EEF4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034" autoAdjust="0"/>
    <p:restoredTop sz="96433" autoAdjust="0"/>
  </p:normalViewPr>
  <p:slideViewPr>
    <p:cSldViewPr snapToGrid="0">
      <p:cViewPr>
        <p:scale>
          <a:sx n="50" d="100"/>
          <a:sy n="50" d="100"/>
        </p:scale>
        <p:origin x="-1812" y="-702"/>
      </p:cViewPr>
      <p:guideLst>
        <p:guide orient="horz" pos="3840"/>
        <p:guide pos="51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3713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4AA62E-F5F7-4644-A832-635A92716D2D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40113" y="849313"/>
            <a:ext cx="30480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3850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3713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53162-EB7D-4FF6-B98E-CC90F3F4CE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044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1995312"/>
            <a:ext cx="13770372" cy="4244622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6403623"/>
            <a:ext cx="12150329" cy="2943577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43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63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649111"/>
            <a:ext cx="3493219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649111"/>
            <a:ext cx="10277153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201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574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3039537"/>
            <a:ext cx="13972878" cy="5071532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8159048"/>
            <a:ext cx="13972878" cy="2666999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/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529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868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649114"/>
            <a:ext cx="13972878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2988734"/>
            <a:ext cx="6853544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4453467"/>
            <a:ext cx="6853544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2988734"/>
            <a:ext cx="6887296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4453467"/>
            <a:ext cx="6887296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38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894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060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755425"/>
            <a:ext cx="8201472" cy="8664222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08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755425"/>
            <a:ext cx="8201472" cy="8664222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649114"/>
            <a:ext cx="13972878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3245556"/>
            <a:ext cx="13972878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1300181"/>
            <a:ext cx="546764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777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95349" y="1429687"/>
            <a:ext cx="1267627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GB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ge of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ands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ruited to </a:t>
            </a:r>
            <a:r>
              <a:rPr lang="en-GB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PS at the time of whole genome sequencing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9607" y="3633854"/>
            <a:ext cx="12061748" cy="64626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28584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PPRESENTATIONGUID" val="60d00e82-6d48-413a-9581-944960035fbc"/>
  <p:tag name="TPVERSION" val="8"/>
  <p:tag name="TPFULLVERSION" val="8.2.3.1"/>
  <p:tag name="PPTVERSION" val="14"/>
  <p:tag name="TPOS" val="2"/>
  <p:tag name="TPLASTSAVEVERSION" val="6.2 PC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07</TotalTime>
  <Words>1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mia Boukhibar</dc:creator>
  <cp:lastModifiedBy>Hywel Williams</cp:lastModifiedBy>
  <cp:revision>151</cp:revision>
  <cp:lastPrinted>2018-02-12T11:49:05Z</cp:lastPrinted>
  <dcterms:created xsi:type="dcterms:W3CDTF">2017-06-01T14:01:27Z</dcterms:created>
  <dcterms:modified xsi:type="dcterms:W3CDTF">2018-03-19T09:33:53Z</dcterms:modified>
</cp:coreProperties>
</file>